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6E76F-431D-C4FB-0E84-978E97689E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DC00CD-E525-44E1-D153-CF7F031F92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7D3596-74F8-36D4-AAD4-899E45C8B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0FF591-FCA5-D840-9B4A-A80FDFB01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B82C90-F782-E921-9F5D-78446A503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85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6393D-0EDA-BC23-740A-57C65DD3F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7E1984-FC79-E0DB-A10E-330932EA91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B64A77-C15A-FD83-8731-BD4DB8D89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E53874-CA61-7130-0266-2CED8B408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D85411-0502-A160-F54B-061F2C00D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0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AF27B0-DD6F-37D8-EE40-68CF774F8B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45D60F-D335-662D-FCE1-9060D5F5C1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4B5029-D8D8-6188-8F4B-2C4423D4D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872F05-D68F-F17F-6E59-1C2312ABF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9908EA-9056-2BDA-3E66-5D93B7314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47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F08FB-0FF9-FAB7-D6A8-553F2E20BF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C40CF7-67D8-1964-746E-83093938BD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431A2D-8D47-E808-D5C1-D3B64DC06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F2AC20-BC78-00AA-0BB8-A65D5943A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B77716-4F59-A048-2C74-39A39FBE0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755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4EDD4-CE82-EAAA-02D5-E34168837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4EB273-DCCA-ADAF-C58B-439BF7DD1E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A11E9C-79AC-7D74-262A-D7FB70760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F1F7D-70D2-1DD0-98DE-87F37B65F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D1136-D84C-5022-C414-1910E9BCB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69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3439C-64A4-C814-9A86-B4E99CB4F2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42434F-33C9-977E-904F-9DE34ADA69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D66BEC-EE9F-4D21-7B35-953D6ACB41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FF703F-177B-1D43-8765-F53C4368B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5394DB-2713-1803-6AA8-CD51F2A7D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0FEA8D-9DF5-2432-13A6-FF4DCC278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909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81F60-6209-2566-EF2B-17E022BD5D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2736C5-40E7-B93A-B32D-BBE37C60AC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36B12A-1077-E0F4-368E-AF0DD76303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C09ACC-D78A-3E7F-8761-3AE37EFDAC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7B5179-0FF2-2DBC-1B60-0B4512CB3C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89D85E8-9894-E5CD-EDFA-8F8686AE1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158354-7B52-A0EE-AE72-80A8E37B7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1988AC-A637-71FE-7279-34308C3B8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568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AC02E-91D3-9F1F-CE22-8BC7DB569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3790B8-9B48-1A90-8152-266A39D3F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FE472C-7DCD-C125-50E6-0EB3F3457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C3485D-BCAC-8B89-0A7A-A30359D8C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451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46B8C8-65E4-A7F8-82EA-BBC4E6409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FE45AA-2332-14FC-EE5D-A10B9F1FD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B5357E-149F-33CB-12EE-4C4A52724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411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DEA75-A72C-7F97-B70A-54D5D37CD7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2E376F-CC96-481E-20E4-F951A2C821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A65B8D-7C99-8C7B-3023-5BA963EFE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83AEDD-328E-DFA1-34D1-8DFFA853A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C9B01A-927D-4C33-B0A1-583A0366A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6182BE-C9B2-DB46-9029-90F397116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100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60C8F3-BCC6-944B-B5D3-9843B90C9D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3FA7A2-9155-D504-72F0-33B54E8883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B7F058-3DBE-4B03-D171-D62C70A851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CDB03D-3056-D1E0-A4F6-411E2EE09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AA0F0A-41E1-7D7B-5C18-0DA5E28EC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C381D3-38BF-80D4-1CAA-6D98B3E79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315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4BAF96-E54B-BDD2-BDAA-D09FC5EC5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93A3F4-CC5B-A91F-151C-96D1AC718A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125B81-3A1A-2662-C36C-130DDA18C8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A8C78F-ED96-4428-91DF-507C0E3ACFDF}" type="datetimeFigureOut">
              <a:rPr lang="en-US" smtClean="0"/>
              <a:t>4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BC400E-AF25-07A9-6F39-EC5016FF1E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DC747-D4B0-4CFD-29E9-8E9BFC3152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80CB8F-77AB-45E6-83C7-3606362D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7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8DBA9C5-2C8F-4616-93D7-F81A05895B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691641" y="2417272"/>
            <a:ext cx="3909059" cy="2233358"/>
          </a:xfrm>
          <a:prstGeom prst="rect">
            <a:avLst/>
          </a:prstGeom>
        </p:spPr>
      </p:pic>
      <p:sp>
        <p:nvSpPr>
          <p:cNvPr id="5" name="TextBox 2">
            <a:extLst>
              <a:ext uri="{FF2B5EF4-FFF2-40B4-BE49-F238E27FC236}">
                <a16:creationId xmlns:a16="http://schemas.microsoft.com/office/drawing/2014/main" id="{F2B473CC-53B8-413D-9908-310605FD12EB}"/>
              </a:ext>
            </a:extLst>
          </p:cNvPr>
          <p:cNvSpPr txBox="1"/>
          <p:nvPr/>
        </p:nvSpPr>
        <p:spPr>
          <a:xfrm>
            <a:off x="2316480" y="2230229"/>
            <a:ext cx="60198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/>
              <a:t>WT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21053F1E-92D0-4202-B4E5-8B4D4882CF47}"/>
              </a:ext>
            </a:extLst>
          </p:cNvPr>
          <p:cNvSpPr txBox="1"/>
          <p:nvPr/>
        </p:nvSpPr>
        <p:spPr>
          <a:xfrm>
            <a:off x="3048000" y="2222609"/>
            <a:ext cx="60198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/>
              <a:t>III-4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5C34A0E9-111B-4621-BF7C-C820141478A3}"/>
              </a:ext>
            </a:extLst>
          </p:cNvPr>
          <p:cNvSpPr txBox="1"/>
          <p:nvPr/>
        </p:nvSpPr>
        <p:spPr>
          <a:xfrm>
            <a:off x="3817620" y="2207369"/>
            <a:ext cx="60198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/>
              <a:t>II-2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AB82675C-34BB-4BF8-A7A3-77AA9F3DD246}"/>
              </a:ext>
            </a:extLst>
          </p:cNvPr>
          <p:cNvSpPr txBox="1"/>
          <p:nvPr/>
        </p:nvSpPr>
        <p:spPr>
          <a:xfrm>
            <a:off x="4594860" y="2207369"/>
            <a:ext cx="100584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III-4 corrected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6381B99E-665C-4D6F-AC8E-A692A40C354C}"/>
              </a:ext>
            </a:extLst>
          </p:cNvPr>
          <p:cNvSpPr txBox="1"/>
          <p:nvPr/>
        </p:nvSpPr>
        <p:spPr>
          <a:xfrm>
            <a:off x="693336" y="3083669"/>
            <a:ext cx="1470744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Lamin</a:t>
            </a:r>
            <a:r>
              <a:rPr lang="en-US" sz="1100" b="1" u="sng" baseline="0" dirty="0"/>
              <a:t> A/C 75 </a:t>
            </a:r>
            <a:r>
              <a:rPr lang="en-US" sz="1100" b="1" u="sng" baseline="0" dirty="0" err="1"/>
              <a:t>KDa</a:t>
            </a:r>
            <a:r>
              <a:rPr lang="en-US" sz="1100" b="1" u="sng" dirty="0"/>
              <a:t> </a:t>
            </a: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87A94282-A027-4BD7-939D-9B33A7F5CC5D}"/>
              </a:ext>
            </a:extLst>
          </p:cNvPr>
          <p:cNvSpPr txBox="1"/>
          <p:nvPr/>
        </p:nvSpPr>
        <p:spPr>
          <a:xfrm>
            <a:off x="693336" y="3342749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Beta</a:t>
            </a:r>
            <a:r>
              <a:rPr lang="en-US" sz="1100" b="1" u="sng" baseline="0" dirty="0"/>
              <a:t> Actin  42 </a:t>
            </a:r>
            <a:r>
              <a:rPr lang="en-US" sz="1100" b="1" u="sng" baseline="0" dirty="0" err="1"/>
              <a:t>KDa</a:t>
            </a:r>
            <a:endParaRPr lang="en-US" sz="1100" b="1" u="sng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E1F6DF21-DABF-4C08-9376-F645B13F6D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7635240" y="2237849"/>
            <a:ext cx="3695700" cy="2301439"/>
          </a:xfrm>
          <a:prstGeom prst="rect">
            <a:avLst/>
          </a:prstGeom>
        </p:spPr>
      </p:pic>
      <p:sp>
        <p:nvSpPr>
          <p:cNvPr id="12" name="TextBox 9">
            <a:extLst>
              <a:ext uri="{FF2B5EF4-FFF2-40B4-BE49-F238E27FC236}">
                <a16:creationId xmlns:a16="http://schemas.microsoft.com/office/drawing/2014/main" id="{89965769-81A0-4D3F-9C16-BD0D4EA55A5D}"/>
              </a:ext>
            </a:extLst>
          </p:cNvPr>
          <p:cNvSpPr txBox="1"/>
          <p:nvPr/>
        </p:nvSpPr>
        <p:spPr>
          <a:xfrm>
            <a:off x="6736080" y="2938889"/>
            <a:ext cx="128016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100" b="1" u="none" baseline="0"/>
              <a:t>75 KDa</a:t>
            </a:r>
            <a:r>
              <a:rPr lang="en-US" sz="1100" b="1" u="none"/>
              <a:t> </a:t>
            </a: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CDA3C733-50F7-40C9-A13F-10612EB281E6}"/>
              </a:ext>
            </a:extLst>
          </p:cNvPr>
          <p:cNvSpPr txBox="1"/>
          <p:nvPr/>
        </p:nvSpPr>
        <p:spPr>
          <a:xfrm>
            <a:off x="6713220" y="3197969"/>
            <a:ext cx="1310640" cy="259080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100" b="1" u="none" baseline="0"/>
              <a:t>42 KDa</a:t>
            </a:r>
            <a:endParaRPr lang="en-US" sz="1100" b="1" u="none"/>
          </a:p>
        </p:txBody>
      </p:sp>
      <p:sp>
        <p:nvSpPr>
          <p:cNvPr id="14" name="Title 13">
            <a:extLst>
              <a:ext uri="{FF2B5EF4-FFF2-40B4-BE49-F238E27FC236}">
                <a16:creationId xmlns:a16="http://schemas.microsoft.com/office/drawing/2014/main" id="{2D050B39-C8D9-D9B9-E19C-6CCF62CCB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2d</a:t>
            </a:r>
          </a:p>
        </p:txBody>
      </p:sp>
    </p:spTree>
    <p:extLst>
      <p:ext uri="{BB962C8B-B14F-4D97-AF65-F5344CB8AC3E}">
        <p14:creationId xmlns:p14="http://schemas.microsoft.com/office/powerpoint/2010/main" val="756315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681D10-BD77-50A1-AB02-634B042A2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F26AF65-3CF4-4BFD-B5AE-EEEA8CE531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4085" y="1764665"/>
            <a:ext cx="4313294" cy="2331922"/>
          </a:xfrm>
          <a:prstGeom prst="rect">
            <a:avLst/>
          </a:prstGeom>
        </p:spPr>
      </p:pic>
      <p:sp>
        <p:nvSpPr>
          <p:cNvPr id="5" name="TextBox 15">
            <a:extLst>
              <a:ext uri="{FF2B5EF4-FFF2-40B4-BE49-F238E27FC236}">
                <a16:creationId xmlns:a16="http://schemas.microsoft.com/office/drawing/2014/main" id="{68075061-7E6E-461E-93FC-5460541D5A8E}"/>
              </a:ext>
            </a:extLst>
          </p:cNvPr>
          <p:cNvSpPr txBox="1"/>
          <p:nvPr/>
        </p:nvSpPr>
        <p:spPr>
          <a:xfrm>
            <a:off x="2635565" y="1999214"/>
            <a:ext cx="606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/>
              <a:t>WT</a:t>
            </a:r>
          </a:p>
        </p:txBody>
      </p:sp>
      <p:sp>
        <p:nvSpPr>
          <p:cNvPr id="6" name="TextBox 18">
            <a:extLst>
              <a:ext uri="{FF2B5EF4-FFF2-40B4-BE49-F238E27FC236}">
                <a16:creationId xmlns:a16="http://schemas.microsoft.com/office/drawing/2014/main" id="{23514D25-DC8C-4B77-9B40-DAE4CFC3FC24}"/>
              </a:ext>
            </a:extLst>
          </p:cNvPr>
          <p:cNvSpPr txBox="1"/>
          <p:nvPr/>
        </p:nvSpPr>
        <p:spPr>
          <a:xfrm>
            <a:off x="3334823" y="1993265"/>
            <a:ext cx="541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/>
              <a:t>III-4</a:t>
            </a:r>
          </a:p>
        </p:txBody>
      </p:sp>
      <p:sp>
        <p:nvSpPr>
          <p:cNvPr id="7" name="TextBox 19">
            <a:extLst>
              <a:ext uri="{FF2B5EF4-FFF2-40B4-BE49-F238E27FC236}">
                <a16:creationId xmlns:a16="http://schemas.microsoft.com/office/drawing/2014/main" id="{AA0A5683-44E0-4E0D-B3C6-0A857598BFAA}"/>
              </a:ext>
            </a:extLst>
          </p:cNvPr>
          <p:cNvSpPr txBox="1"/>
          <p:nvPr/>
        </p:nvSpPr>
        <p:spPr>
          <a:xfrm>
            <a:off x="3871599" y="2001335"/>
            <a:ext cx="5701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dirty="0"/>
              <a:t>II-2</a:t>
            </a:r>
          </a:p>
        </p:txBody>
      </p:sp>
      <p:sp>
        <p:nvSpPr>
          <p:cNvPr id="8" name="TextBox 20">
            <a:extLst>
              <a:ext uri="{FF2B5EF4-FFF2-40B4-BE49-F238E27FC236}">
                <a16:creationId xmlns:a16="http://schemas.microsoft.com/office/drawing/2014/main" id="{C41089EB-5607-4A3D-8A3D-2DD86DE5332E}"/>
              </a:ext>
            </a:extLst>
          </p:cNvPr>
          <p:cNvSpPr txBox="1"/>
          <p:nvPr/>
        </p:nvSpPr>
        <p:spPr>
          <a:xfrm>
            <a:off x="4281550" y="1995983"/>
            <a:ext cx="12738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/>
              <a:t>III-4-Corrected 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4F88244-6254-4C55-B84D-88BDEF668220}"/>
              </a:ext>
            </a:extLst>
          </p:cNvPr>
          <p:cNvCxnSpPr>
            <a:cxnSpLocks/>
          </p:cNvCxnSpPr>
          <p:nvPr/>
        </p:nvCxnSpPr>
        <p:spPr>
          <a:xfrm>
            <a:off x="2734625" y="2252345"/>
            <a:ext cx="449580" cy="762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A40C927-B041-45BF-815E-CAD1C483FC94}"/>
              </a:ext>
            </a:extLst>
          </p:cNvPr>
          <p:cNvCxnSpPr>
            <a:cxnSpLocks/>
          </p:cNvCxnSpPr>
          <p:nvPr/>
        </p:nvCxnSpPr>
        <p:spPr>
          <a:xfrm>
            <a:off x="3336605" y="2259965"/>
            <a:ext cx="449580" cy="762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B0144A0-A5B6-47D4-9078-D28C5E58F4E2}"/>
              </a:ext>
            </a:extLst>
          </p:cNvPr>
          <p:cNvCxnSpPr>
            <a:cxnSpLocks/>
          </p:cNvCxnSpPr>
          <p:nvPr/>
        </p:nvCxnSpPr>
        <p:spPr>
          <a:xfrm>
            <a:off x="4601525" y="2267585"/>
            <a:ext cx="449580" cy="762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2" name="Picture 11">
            <a:extLst>
              <a:ext uri="{FF2B5EF4-FFF2-40B4-BE49-F238E27FC236}">
                <a16:creationId xmlns:a16="http://schemas.microsoft.com/office/drawing/2014/main" id="{C610664A-D917-4FE2-ACD7-FCCBA82474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467925" y="3982484"/>
            <a:ext cx="3451860" cy="15618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7724A26-62A3-4D27-A3A3-87195F21CE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7558085" y="3760157"/>
            <a:ext cx="3438455" cy="199738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21A131A-87BF-4C9D-A054-9EA0A832BEF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88565" y="1825625"/>
            <a:ext cx="3665538" cy="1722269"/>
          </a:xfrm>
          <a:prstGeom prst="rect">
            <a:avLst/>
          </a:prstGeom>
        </p:spPr>
      </p:pic>
      <p:sp>
        <p:nvSpPr>
          <p:cNvPr id="37" name="TextBox 7">
            <a:extLst>
              <a:ext uri="{FF2B5EF4-FFF2-40B4-BE49-F238E27FC236}">
                <a16:creationId xmlns:a16="http://schemas.microsoft.com/office/drawing/2014/main" id="{46645D67-137A-5105-AA30-877A4EB75063}"/>
              </a:ext>
            </a:extLst>
          </p:cNvPr>
          <p:cNvSpPr txBox="1"/>
          <p:nvPr/>
        </p:nvSpPr>
        <p:spPr>
          <a:xfrm>
            <a:off x="989561" y="4829905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Beta</a:t>
            </a:r>
            <a:r>
              <a:rPr lang="en-US" sz="1100" b="1" u="sng" baseline="0" dirty="0"/>
              <a:t> Actin  42 </a:t>
            </a:r>
            <a:r>
              <a:rPr lang="en-US" sz="1100" b="1" u="sng" baseline="0" dirty="0" err="1"/>
              <a:t>KDa</a:t>
            </a:r>
            <a:endParaRPr lang="en-US" sz="1100" b="1" u="sng" dirty="0"/>
          </a:p>
        </p:txBody>
      </p:sp>
      <p:sp>
        <p:nvSpPr>
          <p:cNvPr id="38" name="TextBox 7">
            <a:extLst>
              <a:ext uri="{FF2B5EF4-FFF2-40B4-BE49-F238E27FC236}">
                <a16:creationId xmlns:a16="http://schemas.microsoft.com/office/drawing/2014/main" id="{5A6676F8-893A-1ECA-8BCD-EF7AD7F2AEA3}"/>
              </a:ext>
            </a:extLst>
          </p:cNvPr>
          <p:cNvSpPr txBox="1"/>
          <p:nvPr/>
        </p:nvSpPr>
        <p:spPr>
          <a:xfrm>
            <a:off x="937897" y="2945442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TBX5~ 60</a:t>
            </a:r>
            <a:r>
              <a:rPr lang="en-US" sz="1100" b="1" u="sng" baseline="0" dirty="0"/>
              <a:t>KDa</a:t>
            </a:r>
            <a:endParaRPr lang="en-US" sz="1100" b="1" u="sng" dirty="0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D565B5A-276A-E597-7264-A32887495BA5}"/>
              </a:ext>
            </a:extLst>
          </p:cNvPr>
          <p:cNvCxnSpPr>
            <a:cxnSpLocks/>
          </p:cNvCxnSpPr>
          <p:nvPr/>
        </p:nvCxnSpPr>
        <p:spPr>
          <a:xfrm>
            <a:off x="3900086" y="2258779"/>
            <a:ext cx="449580" cy="762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94738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BE4CD-B279-B29F-7CB8-337F87F93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A88D900-4F51-4F73-A88B-00839EEF50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98594" y="2197319"/>
            <a:ext cx="3991897" cy="2440258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D5D9B826-F10D-4BEB-8480-F560FEE9316E}"/>
              </a:ext>
            </a:extLst>
          </p:cNvPr>
          <p:cNvGrpSpPr/>
          <p:nvPr/>
        </p:nvGrpSpPr>
        <p:grpSpPr>
          <a:xfrm>
            <a:off x="2550633" y="1937579"/>
            <a:ext cx="3873910" cy="2699998"/>
            <a:chOff x="1260696" y="-259740"/>
            <a:chExt cx="3873910" cy="269999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B53F6B2-5DC4-D062-7804-B0D23D12211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60696" y="-259740"/>
              <a:ext cx="3873910" cy="2699998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F9177C29-5622-DF08-5B37-28EB7659D760}"/>
                </a:ext>
              </a:extLst>
            </p:cNvPr>
            <p:cNvCxnSpPr>
              <a:cxnSpLocks/>
            </p:cNvCxnSpPr>
            <p:nvPr/>
          </p:nvCxnSpPr>
          <p:spPr>
            <a:xfrm>
              <a:off x="1801729" y="557330"/>
              <a:ext cx="56043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5CD085FC-D62D-429E-EC66-ACD76B926A81}"/>
                </a:ext>
              </a:extLst>
            </p:cNvPr>
            <p:cNvCxnSpPr>
              <a:cxnSpLocks/>
            </p:cNvCxnSpPr>
            <p:nvPr/>
          </p:nvCxnSpPr>
          <p:spPr>
            <a:xfrm>
              <a:off x="2556940" y="557330"/>
              <a:ext cx="56043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D66126BE-6A04-F983-5976-9F1138D83917}"/>
                </a:ext>
              </a:extLst>
            </p:cNvPr>
            <p:cNvCxnSpPr>
              <a:cxnSpLocks/>
            </p:cNvCxnSpPr>
            <p:nvPr/>
          </p:nvCxnSpPr>
          <p:spPr>
            <a:xfrm>
              <a:off x="3310783" y="557388"/>
              <a:ext cx="56043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44">
              <a:extLst>
                <a:ext uri="{FF2B5EF4-FFF2-40B4-BE49-F238E27FC236}">
                  <a16:creationId xmlns:a16="http://schemas.microsoft.com/office/drawing/2014/main" id="{D04C9631-CA96-3FC5-A566-FBBA1623A99F}"/>
                </a:ext>
              </a:extLst>
            </p:cNvPr>
            <p:cNvSpPr txBox="1"/>
            <p:nvPr/>
          </p:nvSpPr>
          <p:spPr>
            <a:xfrm>
              <a:off x="1727806" y="138371"/>
              <a:ext cx="7273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S143P</a:t>
              </a:r>
            </a:p>
          </p:txBody>
        </p:sp>
        <p:sp>
          <p:nvSpPr>
            <p:cNvPr id="11" name="TextBox 45">
              <a:extLst>
                <a:ext uri="{FF2B5EF4-FFF2-40B4-BE49-F238E27FC236}">
                  <a16:creationId xmlns:a16="http://schemas.microsoft.com/office/drawing/2014/main" id="{D57DEFCF-D1FC-C674-6B5C-6054EB204708}"/>
                </a:ext>
              </a:extLst>
            </p:cNvPr>
            <p:cNvSpPr txBox="1"/>
            <p:nvPr/>
          </p:nvSpPr>
          <p:spPr>
            <a:xfrm>
              <a:off x="3423736" y="150241"/>
              <a:ext cx="7273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S143P</a:t>
              </a:r>
            </a:p>
          </p:txBody>
        </p:sp>
        <p:sp>
          <p:nvSpPr>
            <p:cNvPr id="12" name="TextBox 46">
              <a:extLst>
                <a:ext uri="{FF2B5EF4-FFF2-40B4-BE49-F238E27FC236}">
                  <a16:creationId xmlns:a16="http://schemas.microsoft.com/office/drawing/2014/main" id="{A4D936C6-B69C-3E94-696D-CCF3EE8D443E}"/>
                </a:ext>
              </a:extLst>
            </p:cNvPr>
            <p:cNvSpPr txBox="1"/>
            <p:nvPr/>
          </p:nvSpPr>
          <p:spPr>
            <a:xfrm>
              <a:off x="2362168" y="138371"/>
              <a:ext cx="9340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CRISPR a</a:t>
              </a:r>
            </a:p>
          </p:txBody>
        </p:sp>
      </p:grpSp>
      <p:sp>
        <p:nvSpPr>
          <p:cNvPr id="18" name="TextBox 44">
            <a:extLst>
              <a:ext uri="{FF2B5EF4-FFF2-40B4-BE49-F238E27FC236}">
                <a16:creationId xmlns:a16="http://schemas.microsoft.com/office/drawing/2014/main" id="{C9330650-10AD-1E4A-C051-4012B05D3110}"/>
              </a:ext>
            </a:extLst>
          </p:cNvPr>
          <p:cNvSpPr txBox="1"/>
          <p:nvPr/>
        </p:nvSpPr>
        <p:spPr>
          <a:xfrm>
            <a:off x="7599789" y="2573989"/>
            <a:ext cx="727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S143P</a:t>
            </a:r>
          </a:p>
        </p:txBody>
      </p:sp>
      <p:sp>
        <p:nvSpPr>
          <p:cNvPr id="19" name="TextBox 45">
            <a:extLst>
              <a:ext uri="{FF2B5EF4-FFF2-40B4-BE49-F238E27FC236}">
                <a16:creationId xmlns:a16="http://schemas.microsoft.com/office/drawing/2014/main" id="{664FE61A-C003-F300-C987-FA2AE6AB4E71}"/>
              </a:ext>
            </a:extLst>
          </p:cNvPr>
          <p:cNvSpPr txBox="1"/>
          <p:nvPr/>
        </p:nvSpPr>
        <p:spPr>
          <a:xfrm>
            <a:off x="9295719" y="2585859"/>
            <a:ext cx="727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S143P</a:t>
            </a:r>
          </a:p>
        </p:txBody>
      </p:sp>
      <p:sp>
        <p:nvSpPr>
          <p:cNvPr id="20" name="TextBox 46">
            <a:extLst>
              <a:ext uri="{FF2B5EF4-FFF2-40B4-BE49-F238E27FC236}">
                <a16:creationId xmlns:a16="http://schemas.microsoft.com/office/drawing/2014/main" id="{B26F150E-26B3-219A-DF18-F1E07F64E93A}"/>
              </a:ext>
            </a:extLst>
          </p:cNvPr>
          <p:cNvSpPr txBox="1"/>
          <p:nvPr/>
        </p:nvSpPr>
        <p:spPr>
          <a:xfrm>
            <a:off x="8234151" y="2573989"/>
            <a:ext cx="934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CRISPR a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EE2D5AF-ED91-7AD9-E180-E6CCFD7C756B}"/>
              </a:ext>
            </a:extLst>
          </p:cNvPr>
          <p:cNvCxnSpPr>
            <a:cxnSpLocks/>
          </p:cNvCxnSpPr>
          <p:nvPr/>
        </p:nvCxnSpPr>
        <p:spPr>
          <a:xfrm>
            <a:off x="7737306" y="2897456"/>
            <a:ext cx="5604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09AB75C-2CE8-AB2D-A6E2-1ECCDFAAF581}"/>
              </a:ext>
            </a:extLst>
          </p:cNvPr>
          <p:cNvCxnSpPr>
            <a:cxnSpLocks/>
          </p:cNvCxnSpPr>
          <p:nvPr/>
        </p:nvCxnSpPr>
        <p:spPr>
          <a:xfrm>
            <a:off x="8391151" y="2897456"/>
            <a:ext cx="5604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5B87034-184C-88B2-F66B-65ED6315A1C3}"/>
              </a:ext>
            </a:extLst>
          </p:cNvPr>
          <p:cNvCxnSpPr>
            <a:cxnSpLocks/>
          </p:cNvCxnSpPr>
          <p:nvPr/>
        </p:nvCxnSpPr>
        <p:spPr>
          <a:xfrm>
            <a:off x="9295719" y="2897456"/>
            <a:ext cx="5604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7">
            <a:extLst>
              <a:ext uri="{FF2B5EF4-FFF2-40B4-BE49-F238E27FC236}">
                <a16:creationId xmlns:a16="http://schemas.microsoft.com/office/drawing/2014/main" id="{AD28439A-78A6-B2DA-D50A-467E6F425F9C}"/>
              </a:ext>
            </a:extLst>
          </p:cNvPr>
          <p:cNvSpPr txBox="1"/>
          <p:nvPr/>
        </p:nvSpPr>
        <p:spPr>
          <a:xfrm>
            <a:off x="5720230" y="3287578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Beta</a:t>
            </a:r>
            <a:r>
              <a:rPr lang="en-US" sz="1100" b="1" u="sng" baseline="0" dirty="0"/>
              <a:t> Actin  42 </a:t>
            </a:r>
            <a:r>
              <a:rPr lang="en-US" sz="1100" b="1" u="sng" baseline="0" dirty="0" err="1"/>
              <a:t>KDa</a:t>
            </a:r>
            <a:endParaRPr lang="en-US" sz="1100" b="1" u="sng" dirty="0"/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16B0B213-5A14-149F-2B1E-69126A53202D}"/>
              </a:ext>
            </a:extLst>
          </p:cNvPr>
          <p:cNvSpPr txBox="1"/>
          <p:nvPr/>
        </p:nvSpPr>
        <p:spPr>
          <a:xfrm>
            <a:off x="1216300" y="2881766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TBX5~ 60</a:t>
            </a:r>
            <a:r>
              <a:rPr lang="en-US" sz="1100" b="1" u="sng" baseline="0" dirty="0"/>
              <a:t>KDa</a:t>
            </a:r>
            <a:endParaRPr lang="en-US" sz="1100" b="1" u="sng" dirty="0"/>
          </a:p>
        </p:txBody>
      </p:sp>
    </p:spTree>
    <p:extLst>
      <p:ext uri="{BB962C8B-B14F-4D97-AF65-F5344CB8AC3E}">
        <p14:creationId xmlns:p14="http://schemas.microsoft.com/office/powerpoint/2010/main" val="24005448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8D5AF9-5919-EC96-1007-2797F46B6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h-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D358B5-DA0C-4790-9F0D-928162A6B6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7554122" y="1973125"/>
            <a:ext cx="3078481" cy="2087277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4A3E3438-727B-4A2D-9F49-F44B336203F8}"/>
              </a:ext>
            </a:extLst>
          </p:cNvPr>
          <p:cNvSpPr txBox="1"/>
          <p:nvPr/>
        </p:nvSpPr>
        <p:spPr>
          <a:xfrm>
            <a:off x="8823231" y="2096940"/>
            <a:ext cx="1580710" cy="27699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/>
              <a:t>CRISPRa TBX5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5828B365-180C-45AB-9F5C-B96CA48EDA4B}"/>
              </a:ext>
            </a:extLst>
          </p:cNvPr>
          <p:cNvSpPr txBox="1"/>
          <p:nvPr/>
        </p:nvSpPr>
        <p:spPr>
          <a:xfrm>
            <a:off x="7142642" y="2071337"/>
            <a:ext cx="2007517" cy="27699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/>
              <a:t>S143P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FBB57F23-9E09-4DE2-B31F-F03C25F2B48D}"/>
              </a:ext>
            </a:extLst>
          </p:cNvPr>
          <p:cNvCxnSpPr>
            <a:cxnSpLocks/>
          </p:cNvCxnSpPr>
          <p:nvPr/>
        </p:nvCxnSpPr>
        <p:spPr>
          <a:xfrm>
            <a:off x="7766119" y="2399539"/>
            <a:ext cx="103822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2D250B86-EA21-40F0-A1E2-5191B27423F5}"/>
              </a:ext>
            </a:extLst>
          </p:cNvPr>
          <p:cNvCxnSpPr>
            <a:cxnSpLocks/>
          </p:cNvCxnSpPr>
          <p:nvPr/>
        </p:nvCxnSpPr>
        <p:spPr>
          <a:xfrm>
            <a:off x="8963661" y="2399539"/>
            <a:ext cx="124085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D262BEE8-0A30-4E03-AEF9-1045B31B3184}"/>
              </a:ext>
            </a:extLst>
          </p:cNvPr>
          <p:cNvGrpSpPr/>
          <p:nvPr/>
        </p:nvGrpSpPr>
        <p:grpSpPr>
          <a:xfrm>
            <a:off x="2047310" y="2117889"/>
            <a:ext cx="3784192" cy="1942268"/>
            <a:chOff x="0" y="45704"/>
            <a:chExt cx="3784192" cy="1942268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41539E7-BC0C-8325-B77E-4BC135B0EF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22860" y="45704"/>
              <a:ext cx="3761332" cy="1942268"/>
            </a:xfrm>
            <a:prstGeom prst="rect">
              <a:avLst/>
            </a:prstGeom>
          </p:spPr>
        </p:pic>
        <p:sp>
          <p:nvSpPr>
            <p:cNvPr id="12" name="TextBox 5">
              <a:extLst>
                <a:ext uri="{FF2B5EF4-FFF2-40B4-BE49-F238E27FC236}">
                  <a16:creationId xmlns:a16="http://schemas.microsoft.com/office/drawing/2014/main" id="{6AD3966C-3522-68C0-958C-049A4D36DC73}"/>
                </a:ext>
              </a:extLst>
            </p:cNvPr>
            <p:cNvSpPr txBox="1"/>
            <p:nvPr/>
          </p:nvSpPr>
          <p:spPr>
            <a:xfrm>
              <a:off x="1680589" y="131435"/>
              <a:ext cx="1580710" cy="27699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en-US"/>
              </a:defPPr>
              <a:lvl1pPr marL="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/>
                <a:t>CRISPRa TBX5</a:t>
              </a:r>
            </a:p>
          </p:txBody>
        </p:sp>
        <p:sp>
          <p:nvSpPr>
            <p:cNvPr id="13" name="TextBox 6">
              <a:extLst>
                <a:ext uri="{FF2B5EF4-FFF2-40B4-BE49-F238E27FC236}">
                  <a16:creationId xmlns:a16="http://schemas.microsoft.com/office/drawing/2014/main" id="{409961CD-52F7-0713-EE18-EDC703FBFF17}"/>
                </a:ext>
              </a:extLst>
            </p:cNvPr>
            <p:cNvSpPr txBox="1"/>
            <p:nvPr/>
          </p:nvSpPr>
          <p:spPr>
            <a:xfrm>
              <a:off x="0" y="105832"/>
              <a:ext cx="2007517" cy="2769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>
              <a:defPPr>
                <a:defRPr lang="en-US"/>
              </a:defPPr>
              <a:lvl1pPr marL="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/>
                <a:t>S143P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8E169464-48DB-856E-4E63-B3DE5A2B3203}"/>
                </a:ext>
              </a:extLst>
            </p:cNvPr>
            <p:cNvCxnSpPr>
              <a:cxnSpLocks/>
            </p:cNvCxnSpPr>
            <p:nvPr/>
          </p:nvCxnSpPr>
          <p:spPr>
            <a:xfrm>
              <a:off x="623477" y="434034"/>
              <a:ext cx="103822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BBB63FEA-59C8-8BF7-DAB2-77864852F45A}"/>
                </a:ext>
              </a:extLst>
            </p:cNvPr>
            <p:cNvCxnSpPr>
              <a:cxnSpLocks/>
            </p:cNvCxnSpPr>
            <p:nvPr/>
          </p:nvCxnSpPr>
          <p:spPr>
            <a:xfrm>
              <a:off x="1821019" y="434034"/>
              <a:ext cx="124085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DC380287-779B-49D1-802F-0579137660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7369448" y="4299761"/>
            <a:ext cx="3299459" cy="1912786"/>
          </a:xfrm>
          <a:prstGeom prst="rect">
            <a:avLst/>
          </a:prstGeom>
        </p:spPr>
      </p:pic>
      <p:sp>
        <p:nvSpPr>
          <p:cNvPr id="16" name="TextBox 7">
            <a:extLst>
              <a:ext uri="{FF2B5EF4-FFF2-40B4-BE49-F238E27FC236}">
                <a16:creationId xmlns:a16="http://schemas.microsoft.com/office/drawing/2014/main" id="{64E5051D-D04E-BF46-13AD-7359664AE421}"/>
              </a:ext>
            </a:extLst>
          </p:cNvPr>
          <p:cNvSpPr txBox="1"/>
          <p:nvPr/>
        </p:nvSpPr>
        <p:spPr>
          <a:xfrm>
            <a:off x="6166991" y="3219097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Beta</a:t>
            </a:r>
            <a:r>
              <a:rPr lang="en-US" sz="1100" b="1" u="sng" baseline="0" dirty="0"/>
              <a:t> Actin  42 </a:t>
            </a:r>
            <a:r>
              <a:rPr lang="en-US" sz="1100" b="1" u="sng" baseline="0" dirty="0" err="1"/>
              <a:t>KDa</a:t>
            </a:r>
            <a:endParaRPr lang="en-US" sz="1100" b="1" u="sng" dirty="0"/>
          </a:p>
        </p:txBody>
      </p:sp>
      <p:sp>
        <p:nvSpPr>
          <p:cNvPr id="17" name="TextBox 7">
            <a:extLst>
              <a:ext uri="{FF2B5EF4-FFF2-40B4-BE49-F238E27FC236}">
                <a16:creationId xmlns:a16="http://schemas.microsoft.com/office/drawing/2014/main" id="{A498B294-30A8-F09A-FD69-C0817C3A987F}"/>
              </a:ext>
            </a:extLst>
          </p:cNvPr>
          <p:cNvSpPr txBox="1"/>
          <p:nvPr/>
        </p:nvSpPr>
        <p:spPr>
          <a:xfrm>
            <a:off x="591806" y="2509743"/>
            <a:ext cx="1478364" cy="209903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100" b="1" u="sng" dirty="0"/>
              <a:t>SCN5A~ 200 </a:t>
            </a:r>
            <a:r>
              <a:rPr lang="en-US" sz="1100" b="1" u="sng" baseline="0" dirty="0" err="1"/>
              <a:t>KDa</a:t>
            </a:r>
            <a:endParaRPr lang="en-US" sz="1100" b="1" u="sng" dirty="0"/>
          </a:p>
        </p:txBody>
      </p:sp>
    </p:spTree>
    <p:extLst>
      <p:ext uri="{BB962C8B-B14F-4D97-AF65-F5344CB8AC3E}">
        <p14:creationId xmlns:p14="http://schemas.microsoft.com/office/powerpoint/2010/main" val="11371334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344EBA-9906-CB22-6C8A-B960E7D7D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86033" y="-242008"/>
            <a:ext cx="11852274" cy="1141243"/>
          </a:xfrm>
        </p:spPr>
        <p:txBody>
          <a:bodyPr>
            <a:normAutofit/>
          </a:bodyPr>
          <a:lstStyle/>
          <a:p>
            <a:pPr algn="ctr"/>
            <a:r>
              <a:rPr lang="en-US" sz="2400" b="1" dirty="0"/>
              <a:t>TEM images W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C2F77FC-2F5C-40AA-A42C-A5118E0C4C4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3499" y="3737987"/>
            <a:ext cx="3205444" cy="301789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63AB1DB-DD2B-4F5C-BD60-0B97F7D3094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0107" y="710804"/>
            <a:ext cx="3205444" cy="301789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64F7DA1-57C4-492C-808D-22E43085130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3499" y="710804"/>
            <a:ext cx="3205444" cy="30178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DDDABE-DA4D-4CAA-BC35-78CDC64EF82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735" y="3799285"/>
            <a:ext cx="3205444" cy="3017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43207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8B516B7E-5911-485E-9832-63CA57C032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4330" y="1345813"/>
            <a:ext cx="2814243" cy="26495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9199650-6367-4721-A11C-8A47D9D3690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5575" y="1351714"/>
            <a:ext cx="2814243" cy="26495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058E436-7140-4D4A-8606-E9E1EF88327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3731" y="4004643"/>
            <a:ext cx="2814243" cy="26495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9E82259-7471-44E5-B740-8078D581BA0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4330" y="4208420"/>
            <a:ext cx="2814243" cy="264958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79E5C6D9-1B7A-F02E-5857-F199CA38CBD2}"/>
              </a:ext>
            </a:extLst>
          </p:cNvPr>
          <p:cNvSpPr txBox="1">
            <a:spLocks/>
          </p:cNvSpPr>
          <p:nvPr/>
        </p:nvSpPr>
        <p:spPr>
          <a:xfrm>
            <a:off x="-86033" y="-242008"/>
            <a:ext cx="11852274" cy="11412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b="1" dirty="0"/>
              <a:t>TEM images LMNA-S143P</a:t>
            </a:r>
          </a:p>
        </p:txBody>
      </p:sp>
    </p:spTree>
    <p:extLst>
      <p:ext uri="{BB962C8B-B14F-4D97-AF65-F5344CB8AC3E}">
        <p14:creationId xmlns:p14="http://schemas.microsoft.com/office/powerpoint/2010/main" val="525738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73</Words>
  <Application>Microsoft Office PowerPoint</Application>
  <PresentationFormat>Widescreen</PresentationFormat>
  <Paragraphs>3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Figure 2d</vt:lpstr>
      <vt:lpstr>Figure 4d</vt:lpstr>
      <vt:lpstr>Figure 4f</vt:lpstr>
      <vt:lpstr>Figure 4h-i</vt:lpstr>
      <vt:lpstr>TEM images W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wais, Asia</dc:creator>
  <cp:lastModifiedBy>Owais, Asia</cp:lastModifiedBy>
  <cp:revision>1</cp:revision>
  <dcterms:created xsi:type="dcterms:W3CDTF">2026-04-14T16:27:30Z</dcterms:created>
  <dcterms:modified xsi:type="dcterms:W3CDTF">2026-04-14T16:44:31Z</dcterms:modified>
</cp:coreProperties>
</file>